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5" autoAdjust="0"/>
    <p:restoredTop sz="94660"/>
  </p:normalViewPr>
  <p:slideViewPr>
    <p:cSldViewPr snapToGrid="0">
      <p:cViewPr varScale="1">
        <p:scale>
          <a:sx n="83" d="100"/>
          <a:sy n="83" d="100"/>
        </p:scale>
        <p:origin x="63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BCFD66-D6A5-F68C-5A08-3069B41182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FFEB5D2-1F2A-2472-F015-67673FE4D47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728BCC9-999C-A194-B21F-0C3AE6A320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1F-8686-4D6D-83EE-0C791BA134A9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A009CCA-F48E-50E3-01B9-C025AF5E43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DE939FC-B72F-0A10-6970-B46EB32E6D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49652-2FCF-4E85-9AD9-0F62945B86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12644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C5DAEEE-7A34-4F14-3A05-4153B0F3C9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9D6AC7E-87CF-F132-8D76-6D30B7DF60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A069C55-FDD5-385F-0072-4326199CD6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1F-8686-4D6D-83EE-0C791BA134A9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0E2A552-084E-BF6F-3733-2E2C68789C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200F632-3868-A55F-AE89-0361C1DD73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49652-2FCF-4E85-9AD9-0F62945B86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838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F2B7A5EC-8CD4-FF57-F372-5AFB7622A4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5660D3B-1241-AD7B-D8EF-0E7769C7A2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3E2B444-B522-7061-3384-3C1DAD5C28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1F-8686-4D6D-83EE-0C791BA134A9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F6AD9C4-C2EE-8D64-5C2A-5BABC5C831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EEE958E-49E9-432A-8398-8F357CAFE3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49652-2FCF-4E85-9AD9-0F62945B86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6171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3D73421-808D-FFA5-AB54-40C391D4BA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2B299DD-2D3A-C871-33C8-E337C59C4B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2B042C0-C77B-3EC7-F85B-C4CFD6A2D1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1F-8686-4D6D-83EE-0C791BA134A9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19D37EA-CDE6-F786-77FC-81C2B56C4C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FE853D5-E44B-5FC8-7CF8-BB36712283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49652-2FCF-4E85-9AD9-0F62945B86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9545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CAFD9AC-4DBA-D16E-2D27-ACD284CF5E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EF621FD-4F38-6A26-49E8-42E9546E1D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DD9A6A3-4C0B-D50F-AC6B-089DBF6842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1F-8686-4D6D-83EE-0C791BA134A9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159C65A-6846-D2EC-5EC9-4F92E17B56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A92E7CE-48DE-412D-8EF9-6DB8D92483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49652-2FCF-4E85-9AD9-0F62945B86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19319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AF0D69C-5FCB-9018-CA17-9F8C83EBEC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D18CD5D-B135-9A04-1B7E-D6C3CAD0D74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1399490-2FBF-DA57-7E96-0B3B2F3E20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4C54216-F986-AA1C-559A-CC020967C5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1F-8686-4D6D-83EE-0C791BA134A9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6976EB4-405A-A501-E0C9-A3632DC44C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7A98D6F-62B0-465F-006D-C61B8F9BD7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49652-2FCF-4E85-9AD9-0F62945B86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90184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C0C57C-F97D-7640-CA9F-92FD8C44BA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5F9394C-B053-7243-8B0D-36BA167B9F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976FBFC-87B6-E18E-D4D9-97B57352BC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A835C4A-7199-7C51-C858-16937389B36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C1BF165-991B-5E6D-AACE-F9498EDDA85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28F83B1-5A5B-2F96-D004-B08A162A18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1F-8686-4D6D-83EE-0C791BA134A9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115EA96-FE15-259F-A0FB-80F8A35745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398140B-7179-E1AC-D83B-5DF52C403C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49652-2FCF-4E85-9AD9-0F62945B86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0267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85CB089-81A5-E297-C44F-D266275D34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9A3B5C6-C4E8-045D-2931-2EA66C5BF1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1F-8686-4D6D-83EE-0C791BA134A9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B570FAE-3301-9DD3-EF55-65F6134C2C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868D43C-8EFE-9820-8CB0-8341694D35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49652-2FCF-4E85-9AD9-0F62945B86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15025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83D2F19-D6F1-CF7E-90AA-D938E5598A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1F-8686-4D6D-83EE-0C791BA134A9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A7B1B71-5E0D-532F-4A12-F0C612269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8429C15-98E0-B970-2496-57E5B1089E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49652-2FCF-4E85-9AD9-0F62945B86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7410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99E8BE-0C3A-0762-6A4E-F705E37469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1EC5E47-562E-6D82-90F7-AEFD568E53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346E574-49C6-753F-4297-EEDB639D92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783AAAB-CBA7-177A-FBDB-68AB946FBF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1F-8686-4D6D-83EE-0C791BA134A9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F274BD1-C587-068D-9A5E-9219C06A2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88A58D7-BDE9-8B9C-FE69-57D973FF8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49652-2FCF-4E85-9AD9-0F62945B86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51382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253882-50E8-0C0F-AC97-32E718EC1B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1A2F24F-509C-C81D-CE91-86948EB4DB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B9A1EEE-15EE-1D05-E6B8-A26E986913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6891B17-9AD3-CB49-AEE0-A000F48837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DD1F-8686-4D6D-83EE-0C791BA134A9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A4C03D9-B117-862A-7BD1-DEA1AB5C7F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B1AAAE8-3CEE-7380-147A-49B98B1004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49652-2FCF-4E85-9AD9-0F62945B86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43496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5AF3BDF-8695-AB71-665C-8596E274C1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9C4782D-1767-1177-202C-C498E07D79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C29535C-4EC7-A486-4A12-4F8AB46BABD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82DD1F-8686-4D6D-83EE-0C791BA134A9}" type="datetimeFigureOut">
              <a:rPr kumimoji="1" lang="ja-JP" altLang="en-US" smtClean="0"/>
              <a:t>2024/3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D61D01F-95D9-09E4-34E4-29227053304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052C65D-3DAF-273D-C204-F3F6DD67DC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049652-2FCF-4E85-9AD9-0F62945B86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93842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0D3D14B-7063-38A1-F028-6509EB3609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298" t="5193" r="31940" b="273"/>
          <a:stretch/>
        </p:blipFill>
        <p:spPr bwMode="auto">
          <a:xfrm>
            <a:off x="6724959" y="733704"/>
            <a:ext cx="825397" cy="5601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">
            <a:extLst>
              <a:ext uri="{FF2B5EF4-FFF2-40B4-BE49-F238E27FC236}">
                <a16:creationId xmlns:a16="http://schemas.microsoft.com/office/drawing/2014/main" id="{F703ABF3-F45B-A7CF-3718-F07484E9F49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12" t="5193" r="81352" b="273"/>
          <a:stretch/>
        </p:blipFill>
        <p:spPr bwMode="auto">
          <a:xfrm>
            <a:off x="1198037" y="733700"/>
            <a:ext cx="818445" cy="55726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2">
            <a:extLst>
              <a:ext uri="{FF2B5EF4-FFF2-40B4-BE49-F238E27FC236}">
                <a16:creationId xmlns:a16="http://schemas.microsoft.com/office/drawing/2014/main" id="{153777CB-2552-EAD9-84ED-9C85A886B66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608" t="5298" r="32656" b="1175"/>
          <a:stretch/>
        </p:blipFill>
        <p:spPr bwMode="auto">
          <a:xfrm>
            <a:off x="7685139" y="733705"/>
            <a:ext cx="822628" cy="56010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2">
            <a:extLst>
              <a:ext uri="{FF2B5EF4-FFF2-40B4-BE49-F238E27FC236}">
                <a16:creationId xmlns:a16="http://schemas.microsoft.com/office/drawing/2014/main" id="{D1C9DAFE-7C14-4A73-8353-28FD0CA6DEB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295" t="5072" r="74969" b="1401"/>
          <a:stretch/>
        </p:blipFill>
        <p:spPr bwMode="auto">
          <a:xfrm>
            <a:off x="2133802" y="733700"/>
            <a:ext cx="818542" cy="55731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2">
            <a:extLst>
              <a:ext uri="{FF2B5EF4-FFF2-40B4-BE49-F238E27FC236}">
                <a16:creationId xmlns:a16="http://schemas.microsoft.com/office/drawing/2014/main" id="{0EDB24B8-8952-6391-DB18-655A7C5A70F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042" t="4940" r="32592" b="893"/>
          <a:stretch/>
        </p:blipFill>
        <p:spPr bwMode="auto">
          <a:xfrm>
            <a:off x="8642550" y="733701"/>
            <a:ext cx="675493" cy="56010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2">
            <a:extLst>
              <a:ext uri="{FF2B5EF4-FFF2-40B4-BE49-F238E27FC236}">
                <a16:creationId xmlns:a16="http://schemas.microsoft.com/office/drawing/2014/main" id="{1718C74D-0232-031F-EC13-B9340A2D1AA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63" t="5157" r="80317" b="678"/>
          <a:stretch/>
        </p:blipFill>
        <p:spPr bwMode="auto">
          <a:xfrm>
            <a:off x="3069664" y="733700"/>
            <a:ext cx="751865" cy="55726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Picture 2">
            <a:extLst>
              <a:ext uri="{FF2B5EF4-FFF2-40B4-BE49-F238E27FC236}">
                <a16:creationId xmlns:a16="http://schemas.microsoft.com/office/drawing/2014/main" id="{E1EB9443-0E9F-3736-02C8-1A43BE60AE2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799" t="4568" r="29465" b="936"/>
          <a:stretch/>
        </p:blipFill>
        <p:spPr bwMode="auto">
          <a:xfrm>
            <a:off x="9452826" y="733705"/>
            <a:ext cx="822627" cy="56010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Picture 2">
            <a:extLst>
              <a:ext uri="{FF2B5EF4-FFF2-40B4-BE49-F238E27FC236}">
                <a16:creationId xmlns:a16="http://schemas.microsoft.com/office/drawing/2014/main" id="{9F2B1BAC-299C-B727-4C79-CFD10F0A9DB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47" t="4756" r="77717" b="748"/>
          <a:stretch/>
        </p:blipFill>
        <p:spPr bwMode="auto">
          <a:xfrm>
            <a:off x="3938849" y="733700"/>
            <a:ext cx="818445" cy="55726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Picture 2">
            <a:extLst>
              <a:ext uri="{FF2B5EF4-FFF2-40B4-BE49-F238E27FC236}">
                <a16:creationId xmlns:a16="http://schemas.microsoft.com/office/drawing/2014/main" id="{6B49F702-61F3-BBED-3896-FEF2CB909DD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281" t="5399" r="26021" b="950"/>
          <a:stretch/>
        </p:blipFill>
        <p:spPr bwMode="auto">
          <a:xfrm>
            <a:off x="10410237" y="740219"/>
            <a:ext cx="818444" cy="55945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Picture 2">
            <a:extLst>
              <a:ext uri="{FF2B5EF4-FFF2-40B4-BE49-F238E27FC236}">
                <a16:creationId xmlns:a16="http://schemas.microsoft.com/office/drawing/2014/main" id="{48DFB0D8-D185-4402-2D51-C728EED9A2B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78" t="4989" r="77186" b="1250"/>
          <a:stretch/>
        </p:blipFill>
        <p:spPr bwMode="auto">
          <a:xfrm>
            <a:off x="4874615" y="733700"/>
            <a:ext cx="818446" cy="55726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3ADC7E6-D303-4252-B8AF-66E2579AC766}"/>
              </a:ext>
            </a:extLst>
          </p:cNvPr>
          <p:cNvSpPr txBox="1"/>
          <p:nvPr/>
        </p:nvSpPr>
        <p:spPr>
          <a:xfrm>
            <a:off x="762678" y="1008559"/>
            <a:ext cx="2894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I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10B8D3BF-E6AA-4E18-A226-2751ABFEB433}"/>
              </a:ext>
            </a:extLst>
          </p:cNvPr>
          <p:cNvSpPr txBox="1"/>
          <p:nvPr/>
        </p:nvSpPr>
        <p:spPr>
          <a:xfrm>
            <a:off x="748542" y="1931112"/>
            <a:ext cx="2894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II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DEFB45A1-8A48-43AB-A441-B2CABA80FBFC}"/>
              </a:ext>
            </a:extLst>
          </p:cNvPr>
          <p:cNvSpPr txBox="1"/>
          <p:nvPr/>
        </p:nvSpPr>
        <p:spPr>
          <a:xfrm>
            <a:off x="718336" y="2853665"/>
            <a:ext cx="3498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III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8EA5B63-165D-4976-A3CD-1455C2941DA3}"/>
              </a:ext>
            </a:extLst>
          </p:cNvPr>
          <p:cNvSpPr txBox="1"/>
          <p:nvPr/>
        </p:nvSpPr>
        <p:spPr>
          <a:xfrm>
            <a:off x="626216" y="3776218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VR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DE520EA7-50D2-4456-8AC6-03E8912C56DF}"/>
              </a:ext>
            </a:extLst>
          </p:cNvPr>
          <p:cNvSpPr txBox="1"/>
          <p:nvPr/>
        </p:nvSpPr>
        <p:spPr>
          <a:xfrm>
            <a:off x="636635" y="4698771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VL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3804BCB6-9493-461C-B95C-814C0C87837F}"/>
              </a:ext>
            </a:extLst>
          </p:cNvPr>
          <p:cNvSpPr txBox="1"/>
          <p:nvPr/>
        </p:nvSpPr>
        <p:spPr>
          <a:xfrm>
            <a:off x="606429" y="5621322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VF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77DA631-ACFE-4E6A-8F8D-1AE10604979C}"/>
              </a:ext>
            </a:extLst>
          </p:cNvPr>
          <p:cNvSpPr txBox="1"/>
          <p:nvPr/>
        </p:nvSpPr>
        <p:spPr>
          <a:xfrm>
            <a:off x="6175971" y="1011774"/>
            <a:ext cx="4042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V1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B38E231-741E-48E9-A8FA-578B36B52986}"/>
              </a:ext>
            </a:extLst>
          </p:cNvPr>
          <p:cNvSpPr txBox="1"/>
          <p:nvPr/>
        </p:nvSpPr>
        <p:spPr>
          <a:xfrm>
            <a:off x="6175971" y="1933683"/>
            <a:ext cx="4042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V2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81549AC3-0090-4239-8FDF-E2A2FCB92FE5}"/>
              </a:ext>
            </a:extLst>
          </p:cNvPr>
          <p:cNvSpPr txBox="1"/>
          <p:nvPr/>
        </p:nvSpPr>
        <p:spPr>
          <a:xfrm>
            <a:off x="6175971" y="2855592"/>
            <a:ext cx="4042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V3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99102591-44C7-4865-8668-DF5001E14521}"/>
              </a:ext>
            </a:extLst>
          </p:cNvPr>
          <p:cNvSpPr txBox="1"/>
          <p:nvPr/>
        </p:nvSpPr>
        <p:spPr>
          <a:xfrm>
            <a:off x="6175971" y="3777501"/>
            <a:ext cx="4042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V4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7AFD6082-42AB-4364-B686-D9106B202788}"/>
              </a:ext>
            </a:extLst>
          </p:cNvPr>
          <p:cNvSpPr txBox="1"/>
          <p:nvPr/>
        </p:nvSpPr>
        <p:spPr>
          <a:xfrm>
            <a:off x="6175971" y="4699410"/>
            <a:ext cx="4042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V5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BDE5938E-3274-4DF6-B983-3D974CA5C650}"/>
              </a:ext>
            </a:extLst>
          </p:cNvPr>
          <p:cNvSpPr txBox="1"/>
          <p:nvPr/>
        </p:nvSpPr>
        <p:spPr>
          <a:xfrm>
            <a:off x="6175971" y="5621321"/>
            <a:ext cx="4042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V6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00866BCB-7863-4498-BE4F-FBCF5D01404E}"/>
              </a:ext>
            </a:extLst>
          </p:cNvPr>
          <p:cNvSpPr txBox="1"/>
          <p:nvPr/>
        </p:nvSpPr>
        <p:spPr>
          <a:xfrm>
            <a:off x="1186969" y="435441"/>
            <a:ext cx="8426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X-3 years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A4857E08-3839-4683-A7FD-6D97EBB8C4E7}"/>
              </a:ext>
            </a:extLst>
          </p:cNvPr>
          <p:cNvSpPr txBox="1"/>
          <p:nvPr/>
        </p:nvSpPr>
        <p:spPr>
          <a:xfrm>
            <a:off x="2974993" y="435440"/>
            <a:ext cx="941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TTS onset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4295BC32-2E0E-4B29-816E-A2897E727DB7}"/>
              </a:ext>
            </a:extLst>
          </p:cNvPr>
          <p:cNvSpPr txBox="1"/>
          <p:nvPr/>
        </p:nvSpPr>
        <p:spPr>
          <a:xfrm>
            <a:off x="2040350" y="451423"/>
            <a:ext cx="1021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X-4 months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DD8FDC2E-5257-4F96-8AE2-C1F645314B2E}"/>
              </a:ext>
            </a:extLst>
          </p:cNvPr>
          <p:cNvSpPr txBox="1"/>
          <p:nvPr/>
        </p:nvSpPr>
        <p:spPr>
          <a:xfrm>
            <a:off x="4038893" y="451423"/>
            <a:ext cx="618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ay 5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5A1480B9-01ED-4D5B-A453-574E678E2D0B}"/>
              </a:ext>
            </a:extLst>
          </p:cNvPr>
          <p:cNvSpPr txBox="1"/>
          <p:nvPr/>
        </p:nvSpPr>
        <p:spPr>
          <a:xfrm>
            <a:off x="4946992" y="451423"/>
            <a:ext cx="681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ay 59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24EA4AB-8E0E-DE02-48A6-1B899F1EFC81}"/>
              </a:ext>
            </a:extLst>
          </p:cNvPr>
          <p:cNvSpPr txBox="1"/>
          <p:nvPr/>
        </p:nvSpPr>
        <p:spPr>
          <a:xfrm>
            <a:off x="6718844" y="435441"/>
            <a:ext cx="8426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X-3 years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A84F398-D9A0-9CCE-36C1-03BB57EC30AF}"/>
              </a:ext>
            </a:extLst>
          </p:cNvPr>
          <p:cNvSpPr txBox="1"/>
          <p:nvPr/>
        </p:nvSpPr>
        <p:spPr>
          <a:xfrm>
            <a:off x="8506868" y="435440"/>
            <a:ext cx="941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TTS onset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44EA544-784B-7BB5-6678-6C7D66344C69}"/>
              </a:ext>
            </a:extLst>
          </p:cNvPr>
          <p:cNvSpPr txBox="1"/>
          <p:nvPr/>
        </p:nvSpPr>
        <p:spPr>
          <a:xfrm>
            <a:off x="7572225" y="451423"/>
            <a:ext cx="1021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X-4 months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3EB0AA3-9E1E-952B-C652-17D05AF76B9D}"/>
              </a:ext>
            </a:extLst>
          </p:cNvPr>
          <p:cNvSpPr txBox="1"/>
          <p:nvPr/>
        </p:nvSpPr>
        <p:spPr>
          <a:xfrm>
            <a:off x="9570768" y="451423"/>
            <a:ext cx="618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ay 5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2E7FF59-A671-2405-328C-1CC485FB9F98}"/>
              </a:ext>
            </a:extLst>
          </p:cNvPr>
          <p:cNvSpPr txBox="1"/>
          <p:nvPr/>
        </p:nvSpPr>
        <p:spPr>
          <a:xfrm>
            <a:off x="10478867" y="451423"/>
            <a:ext cx="681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ay 59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94853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ワイド画面</PresentationFormat>
  <Paragraphs>2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瑞貴 市川</dc:creator>
  <cp:lastModifiedBy>瑞貴 市川</cp:lastModifiedBy>
  <cp:revision>1</cp:revision>
  <dcterms:created xsi:type="dcterms:W3CDTF">2024-03-18T03:27:43Z</dcterms:created>
  <dcterms:modified xsi:type="dcterms:W3CDTF">2024-03-18T03:28:07Z</dcterms:modified>
</cp:coreProperties>
</file>